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40" d="100"/>
          <a:sy n="140" d="100"/>
        </p:scale>
        <p:origin x="894" y="74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D1717-DFCC-481F-8D37-A22D1FD68E35}" type="datetimeFigureOut">
              <a:rPr lang="en-NZ" smtClean="0"/>
              <a:t>22/04/2015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D487C5-6DA0-48FB-B8D8-3EEF1ABE370C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4765243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D1717-DFCC-481F-8D37-A22D1FD68E35}" type="datetimeFigureOut">
              <a:rPr lang="en-NZ" smtClean="0"/>
              <a:t>22/04/2015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D487C5-6DA0-48FB-B8D8-3EEF1ABE370C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6411249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D1717-DFCC-481F-8D37-A22D1FD68E35}" type="datetimeFigureOut">
              <a:rPr lang="en-NZ" smtClean="0"/>
              <a:t>22/04/2015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D487C5-6DA0-48FB-B8D8-3EEF1ABE370C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1194593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D1717-DFCC-481F-8D37-A22D1FD68E35}" type="datetimeFigureOut">
              <a:rPr lang="en-NZ" smtClean="0"/>
              <a:t>22/04/2015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D487C5-6DA0-48FB-B8D8-3EEF1ABE370C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1665695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D1717-DFCC-481F-8D37-A22D1FD68E35}" type="datetimeFigureOut">
              <a:rPr lang="en-NZ" smtClean="0"/>
              <a:t>22/04/2015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D487C5-6DA0-48FB-B8D8-3EEF1ABE370C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9569142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D1717-DFCC-481F-8D37-A22D1FD68E35}" type="datetimeFigureOut">
              <a:rPr lang="en-NZ" smtClean="0"/>
              <a:t>22/04/2015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D487C5-6DA0-48FB-B8D8-3EEF1ABE370C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0606854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D1717-DFCC-481F-8D37-A22D1FD68E35}" type="datetimeFigureOut">
              <a:rPr lang="en-NZ" smtClean="0"/>
              <a:t>22/04/2015</a:t>
            </a:fld>
            <a:endParaRPr lang="en-N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D487C5-6DA0-48FB-B8D8-3EEF1ABE370C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6879639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D1717-DFCC-481F-8D37-A22D1FD68E35}" type="datetimeFigureOut">
              <a:rPr lang="en-NZ" smtClean="0"/>
              <a:t>22/04/2015</a:t>
            </a:fld>
            <a:endParaRPr lang="en-N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D487C5-6DA0-48FB-B8D8-3EEF1ABE370C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9812484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D1717-DFCC-481F-8D37-A22D1FD68E35}" type="datetimeFigureOut">
              <a:rPr lang="en-NZ" smtClean="0"/>
              <a:t>22/04/2015</a:t>
            </a:fld>
            <a:endParaRPr lang="en-N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D487C5-6DA0-48FB-B8D8-3EEF1ABE370C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4321623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D1717-DFCC-481F-8D37-A22D1FD68E35}" type="datetimeFigureOut">
              <a:rPr lang="en-NZ" smtClean="0"/>
              <a:t>22/04/2015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D487C5-6DA0-48FB-B8D8-3EEF1ABE370C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8982885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D1717-DFCC-481F-8D37-A22D1FD68E35}" type="datetimeFigureOut">
              <a:rPr lang="en-NZ" smtClean="0"/>
              <a:t>22/04/2015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D487C5-6DA0-48FB-B8D8-3EEF1ABE370C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9188086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7D1717-DFCC-481F-8D37-A22D1FD68E35}" type="datetimeFigureOut">
              <a:rPr lang="en-NZ" smtClean="0"/>
              <a:t>22/04/2015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D487C5-6DA0-48FB-B8D8-3EEF1ABE370C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4225397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76672" y="395536"/>
            <a:ext cx="597666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1200" b="1" dirty="0" smtClean="0"/>
              <a:t>Figure 8. Concentration dependent effects of TNF</a:t>
            </a:r>
            <a:r>
              <a:rPr lang="el-GR" sz="1200" b="1" dirty="0" smtClean="0"/>
              <a:t>α</a:t>
            </a:r>
            <a:r>
              <a:rPr lang="en-NZ" sz="1200" b="1" dirty="0" smtClean="0"/>
              <a:t> and IL-1</a:t>
            </a:r>
            <a:r>
              <a:rPr lang="el-GR" sz="1200" b="1" dirty="0" smtClean="0"/>
              <a:t>β</a:t>
            </a:r>
            <a:r>
              <a:rPr lang="en-NZ" sz="1200" b="1" dirty="0" smtClean="0"/>
              <a:t> treatment on endothelial TEER. </a:t>
            </a:r>
            <a:endParaRPr lang="en-NZ" sz="1200" b="1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33328" y="3997346"/>
            <a:ext cx="3048000" cy="2286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8042" y="3997346"/>
            <a:ext cx="3048000" cy="2286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33328" y="1331640"/>
            <a:ext cx="3048000" cy="2286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7210" y="1331640"/>
            <a:ext cx="3048000" cy="2286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4179097" y="1602221"/>
            <a:ext cx="13564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 smtClean="0"/>
              <a:t>500pg/mL comparison</a:t>
            </a:r>
            <a:endParaRPr lang="en-NZ" sz="1000" dirty="0"/>
          </a:p>
        </p:txBody>
      </p:sp>
      <p:sp>
        <p:nvSpPr>
          <p:cNvPr id="10" name="TextBox 9"/>
          <p:cNvSpPr txBox="1"/>
          <p:nvPr/>
        </p:nvSpPr>
        <p:spPr>
          <a:xfrm>
            <a:off x="1185578" y="1601416"/>
            <a:ext cx="12907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 smtClean="0"/>
              <a:t>50pg/mL comparison</a:t>
            </a:r>
            <a:endParaRPr lang="en-NZ" sz="1000" dirty="0"/>
          </a:p>
        </p:txBody>
      </p:sp>
      <p:sp>
        <p:nvSpPr>
          <p:cNvPr id="11" name="TextBox 10"/>
          <p:cNvSpPr txBox="1"/>
          <p:nvPr/>
        </p:nvSpPr>
        <p:spPr>
          <a:xfrm>
            <a:off x="4101752" y="4248261"/>
            <a:ext cx="12907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 smtClean="0"/>
              <a:t>50ng/mL comparison</a:t>
            </a:r>
            <a:endParaRPr lang="en-NZ" sz="1000" dirty="0"/>
          </a:p>
        </p:txBody>
      </p:sp>
      <p:sp>
        <p:nvSpPr>
          <p:cNvPr id="12" name="TextBox 11"/>
          <p:cNvSpPr txBox="1"/>
          <p:nvPr/>
        </p:nvSpPr>
        <p:spPr>
          <a:xfrm>
            <a:off x="1156817" y="4213370"/>
            <a:ext cx="12250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 smtClean="0"/>
              <a:t>5ng/mL comparison</a:t>
            </a:r>
            <a:endParaRPr lang="en-NZ" sz="1000" dirty="0"/>
          </a:p>
        </p:txBody>
      </p:sp>
    </p:spTree>
    <p:extLst>
      <p:ext uri="{BB962C8B-B14F-4D97-AF65-F5344CB8AC3E}">
        <p14:creationId xmlns:p14="http://schemas.microsoft.com/office/powerpoint/2010/main" val="16722753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</TotalTime>
  <Words>25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The University of Aucklan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User</dc:creator>
  <cp:lastModifiedBy>Windows User</cp:lastModifiedBy>
  <cp:revision>5</cp:revision>
  <dcterms:created xsi:type="dcterms:W3CDTF">2015-04-21T02:07:29Z</dcterms:created>
  <dcterms:modified xsi:type="dcterms:W3CDTF">2015-04-22T03:59:44Z</dcterms:modified>
</cp:coreProperties>
</file>